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0BE442-08F5-4752-856B-9F53F32D3C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B18727-4517-4D98-A9F3-FD67783D12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8E8DB6-49BF-48D8-870E-F1D86623259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E7B8A7-6813-4D6F-853A-9EA58082B8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39B85E-387A-42F1-8919-C7CABEB283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5278E0-37A6-4A30-9DF2-1D5298C0D5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70A64E-196E-460E-9430-F4ABFE6B83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2573B0-2C6C-43CE-AF95-2AEC0B0B59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15A4F1-BF85-48B0-960D-D9FC35B4A1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E78DEB-2AF6-45DC-8337-91E287EEEC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E6802A-F6F8-4CB7-B3FD-345E0098C0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528A53-0A45-4443-B9EE-91383EAD22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FFF8F32-937F-4023-BB63-8C297988073A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de-DE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5" descr=""/>
          <p:cNvPicPr/>
          <p:nvPr/>
        </p:nvPicPr>
        <p:blipFill>
          <a:blip r:embed="rId1"/>
          <a:stretch/>
        </p:blipFill>
        <p:spPr>
          <a:xfrm>
            <a:off x="457200" y="260280"/>
            <a:ext cx="8229600" cy="5865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de-DE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3" descr=""/>
          <p:cNvPicPr/>
          <p:nvPr/>
        </p:nvPicPr>
        <p:blipFill>
          <a:blip r:embed="rId1"/>
          <a:stretch/>
        </p:blipFill>
        <p:spPr>
          <a:xfrm>
            <a:off x="457200" y="260280"/>
            <a:ext cx="8229600" cy="5865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de-DE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3" descr=""/>
          <p:cNvPicPr/>
          <p:nvPr/>
        </p:nvPicPr>
        <p:blipFill>
          <a:blip r:embed="rId1"/>
          <a:stretch/>
        </p:blipFill>
        <p:spPr>
          <a:xfrm>
            <a:off x="457200" y="260280"/>
            <a:ext cx="8229600" cy="5865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de-DE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Picture 3" descr=""/>
          <p:cNvPicPr/>
          <p:nvPr/>
        </p:nvPicPr>
        <p:blipFill>
          <a:blip r:embed="rId1"/>
          <a:stretch/>
        </p:blipFill>
        <p:spPr>
          <a:xfrm>
            <a:off x="457200" y="260280"/>
            <a:ext cx="8229600" cy="5865840"/>
          </a:xfrm>
          <a:prstGeom prst="rect">
            <a:avLst/>
          </a:prstGeom>
          <a:ln w="0">
            <a:noFill/>
          </a:ln>
        </p:spPr>
      </p:pic>
      <p:sp>
        <p:nvSpPr>
          <p:cNvPr id="49" name="TextBox 5"/>
          <p:cNvSpPr/>
          <p:nvPr/>
        </p:nvSpPr>
        <p:spPr>
          <a:xfrm>
            <a:off x="5076720" y="2205000"/>
            <a:ext cx="3240360" cy="946440"/>
          </a:xfrm>
          <a:prstGeom prst="rect">
            <a:avLst/>
          </a:prstGeom>
          <a:solidFill>
            <a:srgbClr val="cccc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This is an enlargenment of th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peaks to illustrate how the software of the MegaBace sequencer identifies peaks when there are stutters.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17T13:33:23Z</dcterms:created>
  <dc:creator>PZHiWi</dc:creator>
  <dc:description/>
  <dc:language>en-US</dc:language>
  <cp:lastModifiedBy>Parzies</cp:lastModifiedBy>
  <dcterms:modified xsi:type="dcterms:W3CDTF">2010-06-17T15:12:06Z</dcterms:modified>
  <cp:revision>2</cp:revision>
  <dc:subject/>
  <dc:title>Folie 1</dc:title>
</cp:coreProperties>
</file>